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894ECB3-218C-4E6A-92D3-70D942ADB405}" v="4" dt="2020-07-05T04:24:52.72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77" autoAdjust="0"/>
    <p:restoredTop sz="86321" autoAdjust="0"/>
  </p:normalViewPr>
  <p:slideViewPr>
    <p:cSldViewPr snapToGrid="0" snapToObjects="1">
      <p:cViewPr varScale="1">
        <p:scale>
          <a:sx n="92" d="100"/>
          <a:sy n="92" d="100"/>
        </p:scale>
        <p:origin x="822" y="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zuta Satoshi" userId="29a9164ecf10307e" providerId="LiveId" clId="{9894ECB3-218C-4E6A-92D3-70D942ADB405}"/>
    <pc:docChg chg="modSld">
      <pc:chgData name="Shizuta Satoshi" userId="29a9164ecf10307e" providerId="LiveId" clId="{9894ECB3-218C-4E6A-92D3-70D942ADB405}" dt="2020-07-05T04:24:52.725" v="8"/>
      <pc:docMkLst>
        <pc:docMk/>
      </pc:docMkLst>
      <pc:sldChg chg="modSp mod">
        <pc:chgData name="Shizuta Satoshi" userId="29a9164ecf10307e" providerId="LiveId" clId="{9894ECB3-218C-4E6A-92D3-70D942ADB405}" dt="2020-07-05T04:24:52.725" v="8"/>
        <pc:sldMkLst>
          <pc:docMk/>
          <pc:sldMk cId="2606108778" sldId="258"/>
        </pc:sldMkLst>
        <pc:spChg chg="mod">
          <ac:chgData name="Shizuta Satoshi" userId="29a9164ecf10307e" providerId="LiveId" clId="{9894ECB3-218C-4E6A-92D3-70D942ADB405}" dt="2020-07-05T04:24:52.725" v="8"/>
          <ac:spMkLst>
            <pc:docMk/>
            <pc:sldMk cId="2606108778" sldId="258"/>
            <ac:spMk id="30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04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023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16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996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381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047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610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194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6737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04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514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595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6684745"/>
              </p:ext>
            </p:extLst>
          </p:nvPr>
        </p:nvGraphicFramePr>
        <p:xfrm>
          <a:off x="4689084" y="4300557"/>
          <a:ext cx="4456450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580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1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9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umulative</a:t>
                      </a:r>
                      <a:r>
                        <a:rPr lang="ja-JP" altLang="en-US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cidence</a:t>
                      </a: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9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9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61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41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96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2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5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7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8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6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3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1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umulative</a:t>
                      </a:r>
                      <a:r>
                        <a:rPr lang="ja-JP" altLang="en-US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cidence</a:t>
                      </a: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14.1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32.7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53.8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8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pic>
        <p:nvPicPr>
          <p:cNvPr id="13" name="図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02424" y="1219200"/>
            <a:ext cx="4406900" cy="2882900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6008861" y="3730695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359441" y="3094992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0</a:t>
            </a:r>
            <a:r>
              <a:rPr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855042" y="1422733"/>
            <a:ext cx="1050989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WRF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23" name="図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60658" y="1559927"/>
            <a:ext cx="215900" cy="419100"/>
          </a:xfrm>
          <a:prstGeom prst="rect">
            <a:avLst/>
          </a:prstGeom>
        </p:spPr>
      </p:pic>
      <p:sp>
        <p:nvSpPr>
          <p:cNvPr id="24" name="テキスト ボックス 23"/>
          <p:cNvSpPr txBox="1"/>
          <p:nvPr/>
        </p:nvSpPr>
        <p:spPr>
          <a:xfrm>
            <a:off x="4723136" y="83407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B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7395304" y="3883731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pic>
        <p:nvPicPr>
          <p:cNvPr id="26" name="図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484" y="1219200"/>
            <a:ext cx="4356100" cy="2882900"/>
          </a:xfrm>
          <a:prstGeom prst="rect">
            <a:avLst/>
          </a:prstGeom>
        </p:spPr>
      </p:pic>
      <p:graphicFrame>
        <p:nvGraphicFramePr>
          <p:cNvPr id="27" name="表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0269761"/>
              </p:ext>
            </p:extLst>
          </p:nvPr>
        </p:nvGraphicFramePr>
        <p:xfrm>
          <a:off x="-16095" y="4288384"/>
          <a:ext cx="4679032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019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09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Maintained </a:t>
                      </a:r>
                      <a:r>
                        <a:rPr lang="en-US" altLang="ja-JP" sz="1050" b="1" i="0" u="none" strike="noStrike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Sinus rhythm</a:t>
                      </a:r>
                      <a:endParaRPr lang="en-US" altLang="ja-JP" sz="1050" b="1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171450" marR="9525" marT="9525" marB="0" anchor="ctr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0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3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4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2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4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2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3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umulative</a:t>
                      </a:r>
                      <a:r>
                        <a:rPr lang="ja-JP" altLang="en-US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cidence</a:t>
                      </a: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Times New Roman"/>
                          <a:cs typeface="Times New Roman"/>
                        </a:rPr>
                        <a:t>16.4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0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u="none" strike="noStrike" dirty="0">
                          <a:effectLst/>
                          <a:latin typeface="Times New Roman"/>
                          <a:cs typeface="Times New Roman"/>
                        </a:rPr>
                        <a:t>39.2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Times New Roman"/>
                          <a:cs typeface="Times New Roman"/>
                        </a:rPr>
                        <a:t>65.6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70.4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Recurrent atrial fibrillation</a:t>
                      </a:r>
                    </a:p>
                  </a:txBody>
                  <a:tcPr marL="171450" marR="9525" marT="9525" marB="0" anchor="ctr">
                    <a:solidFill>
                      <a:srgbClr val="C0504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C0504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C0504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C0504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C0504D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C0504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2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2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2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5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0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umulative</a:t>
                      </a:r>
                      <a:r>
                        <a:rPr lang="ja-JP" altLang="en-US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cidence</a:t>
                      </a: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00" b="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n-US" altLang="ja-JP" sz="1000" b="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.5</a:t>
                      </a:r>
                      <a:r>
                        <a:rPr lang="en-US" altLang="ja-JP" sz="10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4.3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4.0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8.0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28" name="テキスト ボックス 27"/>
          <p:cNvSpPr txBox="1"/>
          <p:nvPr/>
        </p:nvSpPr>
        <p:spPr>
          <a:xfrm>
            <a:off x="1526264" y="3718523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504473" y="3257336"/>
            <a:ext cx="1864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</a:t>
            </a:r>
            <a:r>
              <a:rPr lang="ja-JP" altLang="ja-JP" dirty="0">
                <a:latin typeface="Times New Roman"/>
                <a:cs typeface="Times New Roman"/>
              </a:rPr>
              <a:t>&lt;</a:t>
            </a:r>
            <a:r>
              <a:rPr kumimoji="1" lang="en-US" altLang="ja-JP" dirty="0">
                <a:latin typeface="Times New Roman"/>
                <a:cs typeface="Times New Roman"/>
              </a:rPr>
              <a:t>0.0</a:t>
            </a:r>
            <a:r>
              <a:rPr lang="en-US" altLang="ja-JP" dirty="0">
                <a:latin typeface="Times New Roman"/>
                <a:cs typeface="Times New Roman"/>
              </a:rPr>
              <a:t>0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349086" y="1432309"/>
            <a:ext cx="2339102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>
                <a:latin typeface="Times New Roman"/>
                <a:cs typeface="Times New Roman"/>
              </a:rPr>
              <a:t>Maintained Sinus </a:t>
            </a:r>
            <a:r>
              <a:rPr lang="en-US" altLang="ja-JP" sz="1600" dirty="0">
                <a:latin typeface="Times New Roman"/>
                <a:cs typeface="Times New Roman"/>
              </a:rPr>
              <a:t>Rhythm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Recurrent AF</a:t>
            </a:r>
          </a:p>
        </p:txBody>
      </p:sp>
      <p:pic>
        <p:nvPicPr>
          <p:cNvPr id="31" name="図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33186" y="1557511"/>
            <a:ext cx="215900" cy="419100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2919243" y="388607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-31714" y="834079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A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92100" y="63500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Times New Roman"/>
                <a:cs typeface="Times New Roman"/>
              </a:rPr>
              <a:t>S3 Fig.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0610877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91</Words>
  <Application>Microsoft Office PowerPoint</Application>
  <PresentationFormat>On-screen Show (4:3)</PresentationFormat>
  <Paragraphs>1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治 徹真</dc:creator>
  <cp:lastModifiedBy>chn off31</cp:lastModifiedBy>
  <cp:revision>23</cp:revision>
  <dcterms:created xsi:type="dcterms:W3CDTF">2018-09-18T08:43:24Z</dcterms:created>
  <dcterms:modified xsi:type="dcterms:W3CDTF">2020-10-31T10:19:06Z</dcterms:modified>
</cp:coreProperties>
</file>